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65" r:id="rId2"/>
    <p:sldId id="272" r:id="rId3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99FF"/>
    <a:srgbClr val="00CC99"/>
    <a:srgbClr val="800080"/>
    <a:srgbClr val="6364F8"/>
    <a:srgbClr val="FF00FF"/>
    <a:srgbClr val="5CC179"/>
    <a:srgbClr val="00FD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73" autoAdjust="0"/>
    <p:restoredTop sz="97723" autoAdjust="0"/>
  </p:normalViewPr>
  <p:slideViewPr>
    <p:cSldViewPr snapToGrid="0" snapToObjects="1">
      <p:cViewPr varScale="1">
        <p:scale>
          <a:sx n="91" d="100"/>
          <a:sy n="91" d="100"/>
        </p:scale>
        <p:origin x="3192" y="184"/>
      </p:cViewPr>
      <p:guideLst>
        <p:guide orient="horz" pos="595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2FF0B-0073-674D-8155-C198B42C9D6A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688EAF-3660-E44E-882C-6BCEE97E6D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0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0270EF-892A-40DB-8A42-B84D342E2C47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163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ED41-76FA-5146-BC5D-867466E4E395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6273E-2DC6-9945-8C10-F59366102194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5B729-D324-014C-9978-1B3FED3DC642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574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EDB47-CD55-984B-884B-4B414F215CED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12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15A23-FC0B-504A-84AA-BB3131D33D80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05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0997A-1A5A-A740-9866-3A35D0D4588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28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F646E-CB27-8F4E-A104-844DFCB1F399}" type="datetime1">
              <a:rPr lang="fr-FR" smtClean="0"/>
              <a:t>06/0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69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A702A-5B67-5849-9E34-EE575A2BD018}" type="datetime1">
              <a:rPr lang="fr-FR" smtClean="0"/>
              <a:t>06/0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90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7873-0CEE-6D40-96D5-4BB2FAAB8869}" type="datetime1">
              <a:rPr lang="fr-FR" smtClean="0"/>
              <a:t>06/0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86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45469-297B-D247-954E-26D203AE886F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294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DA7D-F6B0-A84F-83E5-76D147850A6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0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AA41F-B621-B84F-A17E-1E3E344CB607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47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5" name="ZoneTexte 74">
            <a:extLst>
              <a:ext uri="{FF2B5EF4-FFF2-40B4-BE49-F238E27FC236}">
                <a16:creationId xmlns:a16="http://schemas.microsoft.com/office/drawing/2014/main" id="{ECAA0A5B-A2AB-C952-092E-F35AD3EF21BB}"/>
              </a:ext>
            </a:extLst>
          </p:cNvPr>
          <p:cNvSpPr txBox="1"/>
          <p:nvPr/>
        </p:nvSpPr>
        <p:spPr>
          <a:xfrm>
            <a:off x="1035023" y="8416965"/>
            <a:ext cx="688009" cy="415498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MDDC 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xposed to: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848</a:t>
            </a:r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E2D32A20-6377-6CC6-1FDF-3DD5A742FB3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76423" y="4708934"/>
            <a:ext cx="1807839" cy="1789818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D2A02827-C06A-D99F-011D-1D81AE73686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76423" y="3223156"/>
            <a:ext cx="1809648" cy="1433954"/>
          </a:xfrm>
          <a:prstGeom prst="rect">
            <a:avLst/>
          </a:prstGeom>
        </p:spPr>
      </p:pic>
      <p:sp>
        <p:nvSpPr>
          <p:cNvPr id="24" name="ZoneTexte 23">
            <a:extLst>
              <a:ext uri="{FF2B5EF4-FFF2-40B4-BE49-F238E27FC236}">
                <a16:creationId xmlns:a16="http://schemas.microsoft.com/office/drawing/2014/main" id="{9FAD2A59-1213-49F6-89D2-65C62FA2F807}"/>
              </a:ext>
            </a:extLst>
          </p:cNvPr>
          <p:cNvSpPr txBox="1"/>
          <p:nvPr/>
        </p:nvSpPr>
        <p:spPr>
          <a:xfrm>
            <a:off x="446491" y="4686184"/>
            <a:ext cx="870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80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725A00C2-D66B-4933-8740-A7017106E8A9}"/>
              </a:ext>
            </a:extLst>
          </p:cNvPr>
          <p:cNvSpPr txBox="1"/>
          <p:nvPr/>
        </p:nvSpPr>
        <p:spPr>
          <a:xfrm>
            <a:off x="446490" y="3183828"/>
            <a:ext cx="870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CD83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84917724-A231-E6B5-3CD5-E1198FEAE77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17251" y="3210083"/>
            <a:ext cx="1880363" cy="1433954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61C2B8C7-A1E8-70EF-01C5-46F7B4EFF2A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17251" y="4703301"/>
            <a:ext cx="1880363" cy="18000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6D2B091D-3FB6-BCF2-68B1-2BCD729E8FF8}"/>
              </a:ext>
            </a:extLst>
          </p:cNvPr>
          <p:cNvSpPr txBox="1"/>
          <p:nvPr/>
        </p:nvSpPr>
        <p:spPr>
          <a:xfrm>
            <a:off x="1030581" y="6132572"/>
            <a:ext cx="68800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MDDC 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xposed to: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E0A651A6-2C4A-6F1E-4F2F-97B48F0D2EBB}"/>
              </a:ext>
            </a:extLst>
          </p:cNvPr>
          <p:cNvSpPr txBox="1"/>
          <p:nvPr/>
        </p:nvSpPr>
        <p:spPr>
          <a:xfrm>
            <a:off x="4500552" y="4871933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34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0ECEC9A7-1BD2-5D73-4475-9611218E1B69}"/>
              </a:ext>
            </a:extLst>
          </p:cNvPr>
          <p:cNvSpPr txBox="1"/>
          <p:nvPr/>
        </p:nvSpPr>
        <p:spPr>
          <a:xfrm>
            <a:off x="4797298" y="4758204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3452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6450F250-0720-6947-2718-7A821F3CAF32}"/>
              </a:ext>
            </a:extLst>
          </p:cNvPr>
          <p:cNvSpPr txBox="1"/>
          <p:nvPr/>
        </p:nvSpPr>
        <p:spPr>
          <a:xfrm>
            <a:off x="4202012" y="4758204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57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EAE18FEB-C6A9-99C1-96CE-91577E0E2172}"/>
              </a:ext>
            </a:extLst>
          </p:cNvPr>
          <p:cNvSpPr txBox="1"/>
          <p:nvPr/>
        </p:nvSpPr>
        <p:spPr>
          <a:xfrm>
            <a:off x="2305687" y="4878451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557290D8-AB10-B00A-7A3C-ECC6707A2FD5}"/>
              </a:ext>
            </a:extLst>
          </p:cNvPr>
          <p:cNvSpPr txBox="1"/>
          <p:nvPr/>
        </p:nvSpPr>
        <p:spPr>
          <a:xfrm>
            <a:off x="2602433" y="4743467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133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AE0758AD-1DBC-E44C-53D4-D17D7637484D}"/>
              </a:ext>
            </a:extLst>
          </p:cNvPr>
          <p:cNvSpPr txBox="1"/>
          <p:nvPr/>
        </p:nvSpPr>
        <p:spPr>
          <a:xfrm>
            <a:off x="2024903" y="5013436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CC78D48F-0E5F-5F61-7A2E-FC780B2289E5}"/>
              </a:ext>
            </a:extLst>
          </p:cNvPr>
          <p:cNvSpPr txBox="1"/>
          <p:nvPr/>
        </p:nvSpPr>
        <p:spPr>
          <a:xfrm>
            <a:off x="4503535" y="3426808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162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542328A9-F7B6-9B9C-D98A-10ADA5FF2A35}"/>
              </a:ext>
            </a:extLst>
          </p:cNvPr>
          <p:cNvSpPr txBox="1"/>
          <p:nvPr/>
        </p:nvSpPr>
        <p:spPr>
          <a:xfrm>
            <a:off x="4800281" y="3295323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7954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BCE912E7-690C-BD64-C91E-56A427FC8544}"/>
              </a:ext>
            </a:extLst>
          </p:cNvPr>
          <p:cNvSpPr txBox="1"/>
          <p:nvPr/>
        </p:nvSpPr>
        <p:spPr>
          <a:xfrm>
            <a:off x="4204995" y="3295323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23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4E7613EA-D6AD-36BB-FCC3-86706DA3B428}"/>
              </a:ext>
            </a:extLst>
          </p:cNvPr>
          <p:cNvSpPr txBox="1"/>
          <p:nvPr/>
        </p:nvSpPr>
        <p:spPr>
          <a:xfrm>
            <a:off x="2308424" y="3189805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2008300F-F44D-B500-2009-3DB41B3042BA}"/>
              </a:ext>
            </a:extLst>
          </p:cNvPr>
          <p:cNvSpPr txBox="1"/>
          <p:nvPr/>
        </p:nvSpPr>
        <p:spPr>
          <a:xfrm>
            <a:off x="2588671" y="3270245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2178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B5FBC889-BB3B-6CAB-649B-D03EEE2D2B63}"/>
              </a:ext>
            </a:extLst>
          </p:cNvPr>
          <p:cNvSpPr txBox="1"/>
          <p:nvPr/>
        </p:nvSpPr>
        <p:spPr>
          <a:xfrm>
            <a:off x="2027903" y="3574286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pic>
        <p:nvPicPr>
          <p:cNvPr id="72" name="Image 71">
            <a:extLst>
              <a:ext uri="{FF2B5EF4-FFF2-40B4-BE49-F238E27FC236}">
                <a16:creationId xmlns:a16="http://schemas.microsoft.com/office/drawing/2014/main" id="{93341AA9-C1D5-4550-8B7F-2B5DC4D58262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5063" y="7026377"/>
            <a:ext cx="1807839" cy="1800000"/>
          </a:xfrm>
          <a:prstGeom prst="rect">
            <a:avLst/>
          </a:prstGeom>
        </p:spPr>
      </p:pic>
      <p:pic>
        <p:nvPicPr>
          <p:cNvPr id="73" name="Image 72">
            <a:extLst>
              <a:ext uri="{FF2B5EF4-FFF2-40B4-BE49-F238E27FC236}">
                <a16:creationId xmlns:a16="http://schemas.microsoft.com/office/drawing/2014/main" id="{6AA1DEFF-FDF5-74B9-52CB-3069ECE4ADD4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5891" y="7028478"/>
            <a:ext cx="1880363" cy="1800000"/>
          </a:xfrm>
          <a:prstGeom prst="rect">
            <a:avLst/>
          </a:prstGeom>
        </p:spPr>
      </p:pic>
      <p:sp>
        <p:nvSpPr>
          <p:cNvPr id="74" name="ZoneTexte 73">
            <a:extLst>
              <a:ext uri="{FF2B5EF4-FFF2-40B4-BE49-F238E27FC236}">
                <a16:creationId xmlns:a16="http://schemas.microsoft.com/office/drawing/2014/main" id="{075FAA2A-1CED-3432-A4A5-5B589628106B}"/>
              </a:ext>
            </a:extLst>
          </p:cNvPr>
          <p:cNvSpPr txBox="1"/>
          <p:nvPr/>
        </p:nvSpPr>
        <p:spPr>
          <a:xfrm>
            <a:off x="455130" y="6918627"/>
            <a:ext cx="870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d 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CD86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3ACFFEB5-2E9B-BE04-8370-15CCFF782916}"/>
              </a:ext>
            </a:extLst>
          </p:cNvPr>
          <p:cNvSpPr txBox="1"/>
          <p:nvPr/>
        </p:nvSpPr>
        <p:spPr>
          <a:xfrm>
            <a:off x="4519039" y="7148831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1164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2F8AFBE8-306D-2FFE-9ADA-01098CBF141C}"/>
              </a:ext>
            </a:extLst>
          </p:cNvPr>
          <p:cNvSpPr txBox="1"/>
          <p:nvPr/>
        </p:nvSpPr>
        <p:spPr>
          <a:xfrm>
            <a:off x="4806907" y="6996091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6730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E1260EB8-4FCA-F5E3-1935-A30311145B3A}"/>
              </a:ext>
            </a:extLst>
          </p:cNvPr>
          <p:cNvSpPr txBox="1"/>
          <p:nvPr/>
        </p:nvSpPr>
        <p:spPr>
          <a:xfrm>
            <a:off x="4220499" y="7301572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14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9212DA6A-1968-F7C3-C552-554F089AB509}"/>
              </a:ext>
            </a:extLst>
          </p:cNvPr>
          <p:cNvSpPr txBox="1"/>
          <p:nvPr/>
        </p:nvSpPr>
        <p:spPr>
          <a:xfrm>
            <a:off x="2322379" y="7213994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15</a:t>
            </a:r>
          </a:p>
        </p:txBody>
      </p:sp>
      <p:sp>
        <p:nvSpPr>
          <p:cNvPr id="80" name="ZoneTexte 79">
            <a:extLst>
              <a:ext uri="{FF2B5EF4-FFF2-40B4-BE49-F238E27FC236}">
                <a16:creationId xmlns:a16="http://schemas.microsoft.com/office/drawing/2014/main" id="{A82F30D8-B675-510D-B902-51CEE3772AB9}"/>
              </a:ext>
            </a:extLst>
          </p:cNvPr>
          <p:cNvSpPr txBox="1"/>
          <p:nvPr/>
        </p:nvSpPr>
        <p:spPr>
          <a:xfrm>
            <a:off x="2601369" y="7061254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2583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9190D5D9-D229-7DC4-D6B8-3E55CAA9B85E}"/>
              </a:ext>
            </a:extLst>
          </p:cNvPr>
          <p:cNvSpPr txBox="1"/>
          <p:nvPr/>
        </p:nvSpPr>
        <p:spPr>
          <a:xfrm>
            <a:off x="2023839" y="7366735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lt;0,0001</a:t>
            </a:r>
          </a:p>
        </p:txBody>
      </p:sp>
      <p:pic>
        <p:nvPicPr>
          <p:cNvPr id="93" name="Image 92">
            <a:extLst>
              <a:ext uri="{FF2B5EF4-FFF2-40B4-BE49-F238E27FC236}">
                <a16:creationId xmlns:a16="http://schemas.microsoft.com/office/drawing/2014/main" id="{C2B8EC81-C654-7B49-E345-A7939043CABF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6423" y="1074669"/>
            <a:ext cx="2142559" cy="1800000"/>
          </a:xfrm>
          <a:prstGeom prst="rect">
            <a:avLst/>
          </a:prstGeom>
        </p:spPr>
      </p:pic>
      <p:pic>
        <p:nvPicPr>
          <p:cNvPr id="94" name="Image 93">
            <a:extLst>
              <a:ext uri="{FF2B5EF4-FFF2-40B4-BE49-F238E27FC236}">
                <a16:creationId xmlns:a16="http://schemas.microsoft.com/office/drawing/2014/main" id="{5947D50B-9BFC-A2D5-C2D8-A342A4EDE8E8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7251" y="1077523"/>
            <a:ext cx="2358621" cy="1800000"/>
          </a:xfrm>
          <a:prstGeom prst="rect">
            <a:avLst/>
          </a:prstGeom>
        </p:spPr>
      </p:pic>
      <p:sp>
        <p:nvSpPr>
          <p:cNvPr id="95" name="ZoneTexte 94">
            <a:extLst>
              <a:ext uri="{FF2B5EF4-FFF2-40B4-BE49-F238E27FC236}">
                <a16:creationId xmlns:a16="http://schemas.microsoft.com/office/drawing/2014/main" id="{996CC12E-CB96-0C93-D0F4-503C90D72AA3}"/>
              </a:ext>
            </a:extLst>
          </p:cNvPr>
          <p:cNvSpPr txBox="1"/>
          <p:nvPr/>
        </p:nvSpPr>
        <p:spPr>
          <a:xfrm>
            <a:off x="2400291" y="121141"/>
            <a:ext cx="2223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sp>
        <p:nvSpPr>
          <p:cNvPr id="96" name="ZoneTexte 95">
            <a:extLst>
              <a:ext uri="{FF2B5EF4-FFF2-40B4-BE49-F238E27FC236}">
                <a16:creationId xmlns:a16="http://schemas.microsoft.com/office/drawing/2014/main" id="{AD877CD6-6D00-D3DE-E350-D9A9B1D6D645}"/>
              </a:ext>
            </a:extLst>
          </p:cNvPr>
          <p:cNvSpPr txBox="1"/>
          <p:nvPr/>
        </p:nvSpPr>
        <p:spPr>
          <a:xfrm>
            <a:off x="446490" y="993952"/>
            <a:ext cx="8705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CD86</a:t>
            </a:r>
          </a:p>
        </p:txBody>
      </p:sp>
      <p:sp>
        <p:nvSpPr>
          <p:cNvPr id="97" name="ZoneTexte 96">
            <a:extLst>
              <a:ext uri="{FF2B5EF4-FFF2-40B4-BE49-F238E27FC236}">
                <a16:creationId xmlns:a16="http://schemas.microsoft.com/office/drawing/2014/main" id="{D42C9BBC-A4B8-3DA1-EA67-B53233CAE50D}"/>
              </a:ext>
            </a:extLst>
          </p:cNvPr>
          <p:cNvSpPr txBox="1"/>
          <p:nvPr/>
        </p:nvSpPr>
        <p:spPr>
          <a:xfrm>
            <a:off x="1023910" y="2453453"/>
            <a:ext cx="68800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MDDC 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xposed to: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98" name="ZoneTexte 97">
            <a:extLst>
              <a:ext uri="{FF2B5EF4-FFF2-40B4-BE49-F238E27FC236}">
                <a16:creationId xmlns:a16="http://schemas.microsoft.com/office/drawing/2014/main" id="{5DA7EF93-11BE-0E89-268F-BAADEF8F115D}"/>
              </a:ext>
            </a:extLst>
          </p:cNvPr>
          <p:cNvSpPr txBox="1"/>
          <p:nvPr/>
        </p:nvSpPr>
        <p:spPr>
          <a:xfrm>
            <a:off x="2658932" y="1533746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99" name="ZoneTexte 98">
            <a:extLst>
              <a:ext uri="{FF2B5EF4-FFF2-40B4-BE49-F238E27FC236}">
                <a16:creationId xmlns:a16="http://schemas.microsoft.com/office/drawing/2014/main" id="{20C08F67-6910-8C17-D485-08722FCA981F}"/>
              </a:ext>
            </a:extLst>
          </p:cNvPr>
          <p:cNvSpPr txBox="1"/>
          <p:nvPr/>
        </p:nvSpPr>
        <p:spPr>
          <a:xfrm>
            <a:off x="2440293" y="1677609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00" name="ZoneTexte 99">
            <a:extLst>
              <a:ext uri="{FF2B5EF4-FFF2-40B4-BE49-F238E27FC236}">
                <a16:creationId xmlns:a16="http://schemas.microsoft.com/office/drawing/2014/main" id="{16E8354C-C8B0-F3D0-E906-2C719B243B0C}"/>
              </a:ext>
            </a:extLst>
          </p:cNvPr>
          <p:cNvSpPr txBox="1"/>
          <p:nvPr/>
        </p:nvSpPr>
        <p:spPr>
          <a:xfrm>
            <a:off x="4965476" y="1166712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01" name="ZoneTexte 100">
            <a:extLst>
              <a:ext uri="{FF2B5EF4-FFF2-40B4-BE49-F238E27FC236}">
                <a16:creationId xmlns:a16="http://schemas.microsoft.com/office/drawing/2014/main" id="{DECD8DCF-7523-6CBC-13CB-DD57A879E201}"/>
              </a:ext>
            </a:extLst>
          </p:cNvPr>
          <p:cNvSpPr txBox="1"/>
          <p:nvPr/>
        </p:nvSpPr>
        <p:spPr>
          <a:xfrm>
            <a:off x="4684692" y="1310575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7162DE2E-1A73-05BB-B1E3-811C9D7C1DAB}"/>
              </a:ext>
            </a:extLst>
          </p:cNvPr>
          <p:cNvSpPr txBox="1"/>
          <p:nvPr/>
        </p:nvSpPr>
        <p:spPr>
          <a:xfrm>
            <a:off x="5235794" y="1017230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256</a:t>
            </a:r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1739DA74-680E-7321-876B-4B9BFC114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352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AB1AF931-8E2E-208A-BBC3-4C8588D15D59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7984" y="1167070"/>
            <a:ext cx="2123937" cy="18000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B7B652E5-5C70-17A9-D777-EAF584244F07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7156" y="1174516"/>
            <a:ext cx="2096400" cy="1800000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787C7A32-FAA3-6398-374D-F551BF1BAA4A}"/>
              </a:ext>
            </a:extLst>
          </p:cNvPr>
          <p:cNvSpPr txBox="1"/>
          <p:nvPr/>
        </p:nvSpPr>
        <p:spPr>
          <a:xfrm>
            <a:off x="826301" y="1136544"/>
            <a:ext cx="153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739BD518-B1AD-2AE3-233A-65BFD1546D21}"/>
              </a:ext>
            </a:extLst>
          </p:cNvPr>
          <p:cNvSpPr txBox="1"/>
          <p:nvPr/>
        </p:nvSpPr>
        <p:spPr>
          <a:xfrm>
            <a:off x="1110153" y="2542054"/>
            <a:ext cx="68800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MDDC 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xposed to: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61BFE7DE-E1E9-F546-1456-B0E6D47224FC}"/>
              </a:ext>
            </a:extLst>
          </p:cNvPr>
          <p:cNvSpPr txBox="1"/>
          <p:nvPr/>
        </p:nvSpPr>
        <p:spPr>
          <a:xfrm>
            <a:off x="4516401" y="1284440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996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0FD771AD-63B0-3494-6670-67CFB83BDD8C}"/>
              </a:ext>
            </a:extLst>
          </p:cNvPr>
          <p:cNvSpPr txBox="1"/>
          <p:nvPr/>
        </p:nvSpPr>
        <p:spPr>
          <a:xfrm>
            <a:off x="4839781" y="1167070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8941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DE11CE7A-98C9-A166-304A-F54BE8C3488F}"/>
              </a:ext>
            </a:extLst>
          </p:cNvPr>
          <p:cNvSpPr txBox="1"/>
          <p:nvPr/>
        </p:nvSpPr>
        <p:spPr>
          <a:xfrm>
            <a:off x="4217861" y="1179589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199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42B4115D-34A4-EE67-7CC3-88426C5F9BE9}"/>
              </a:ext>
            </a:extLst>
          </p:cNvPr>
          <p:cNvSpPr txBox="1"/>
          <p:nvPr/>
        </p:nvSpPr>
        <p:spPr>
          <a:xfrm>
            <a:off x="2377463" y="1408471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109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BC566E53-B271-A515-42E1-4B27BDD691F0}"/>
              </a:ext>
            </a:extLst>
          </p:cNvPr>
          <p:cNvSpPr txBox="1"/>
          <p:nvPr/>
        </p:nvSpPr>
        <p:spPr>
          <a:xfrm>
            <a:off x="2665331" y="1255731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491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123F9DA4-60AD-F0E5-D259-E065DEBAA590}"/>
              </a:ext>
            </a:extLst>
          </p:cNvPr>
          <p:cNvSpPr txBox="1"/>
          <p:nvPr/>
        </p:nvSpPr>
        <p:spPr>
          <a:xfrm>
            <a:off x="2078923" y="1561212"/>
            <a:ext cx="490469" cy="92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600" i="1" dirty="0">
                <a:latin typeface="Arial" panose="020B0604020202020204" pitchFamily="34" charset="0"/>
                <a:cs typeface="Arial" panose="020B0604020202020204" pitchFamily="34" charset="0"/>
              </a:rPr>
              <a:t>p=0.0074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F96CD9FC-8B98-5B44-986F-FFA4B16F1322}"/>
              </a:ext>
            </a:extLst>
          </p:cNvPr>
          <p:cNvSpPr txBox="1"/>
          <p:nvPr/>
        </p:nvSpPr>
        <p:spPr>
          <a:xfrm>
            <a:off x="419022" y="3208471"/>
            <a:ext cx="6019955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5. Pre-exposure to HTLV-1-infected T cells dampens the responsiveness of MDDCs to subsequent stimulation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is figure is relative to Fig. 3. MDDCs were cocultured with uninfected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CEM, Molt-4, red bars) or HTLV-1-infected T cells (C91-PL, MT-2, Hut102, dark blue bars) for 24h, before restimulation with LP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-c, 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or R848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for an additional 24h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-d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low cytometry analysis after CD11c and CD86, CD83 and CD80 staining. The normalized MFI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ef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and percentage of positive MDDC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igh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was determined in n=5-30 independent experiments. Detailed statistical analysis is presented in Supplementary Table 8. Briefly, data were analyzed with ordinary one-way ANOVA or Kruskal-Wallis test, in accordance with the distribution of the dataset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upernatant from the indicated cocultures was collected after LPS restimulation, and TNF-α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ef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and IFN-I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igh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concentrations were quantified for n=10 or 4-5  independent experiments, respectively. Data were analyzed using RM one-way ANOVA or ordinary one-way ANOVA, respectively, as presented in Supplementary Table 8.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fr-FR" sz="1200" dirty="0"/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2BE20DA2-D4A1-46F1-7603-4D7117CAF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8537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33</TotalTime>
  <Words>334</Words>
  <Application>Microsoft Macintosh PowerPoint</Application>
  <PresentationFormat>Format A4 (210 x 297 mm)</PresentationFormat>
  <Paragraphs>52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icrosoft Office User</dc:creator>
  <cp:keywords/>
  <dc:description/>
  <cp:lastModifiedBy>helene</cp:lastModifiedBy>
  <cp:revision>224</cp:revision>
  <cp:lastPrinted>2024-05-03T15:39:09Z</cp:lastPrinted>
  <dcterms:created xsi:type="dcterms:W3CDTF">2023-02-24T13:22:32Z</dcterms:created>
  <dcterms:modified xsi:type="dcterms:W3CDTF">2024-05-06T10:08:56Z</dcterms:modified>
  <cp:category/>
</cp:coreProperties>
</file>